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5" d="100"/>
          <a:sy n="65" d="100"/>
        </p:scale>
        <p:origin x="1536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7114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76217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2069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7845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43843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4281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5335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76830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88620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02669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45540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47B45-B6F2-4091-917A-AC429AF5215D}" type="datetimeFigureOut">
              <a:rPr lang="en-IN" smtClean="0"/>
              <a:t>03-11-2024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05C45-17F0-49DC-A2ED-7F6BE9249AB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76268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0" name="TextBox 26"/>
          <p:cNvSpPr txBox="1">
            <a:spLocks noChangeArrowheads="1"/>
          </p:cNvSpPr>
          <p:nvPr/>
        </p:nvSpPr>
        <p:spPr bwMode="auto">
          <a:xfrm>
            <a:off x="6176597" y="261938"/>
            <a:ext cx="2927838" cy="67403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/>
            <a:r>
              <a:rPr lang="en-US">
                <a:latin typeface="Times New Roman" pitchFamily="18" charset="0"/>
                <a:ea typeface="DengXian" pitchFamily="2" charset="-122"/>
              </a:rPr>
              <a:t>Supplementary Figure 5 Well diffusion assay to check chemical compatibility of bacterial endophytes. 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Bacterial endophytes belonging to genus </a:t>
            </a:r>
            <a:r>
              <a:rPr lang="en-US" i="1" dirty="0">
                <a:latin typeface="Times New Roman" pitchFamily="18" charset="0"/>
                <a:ea typeface="DengXian" pitchFamily="2" charset="-122"/>
              </a:rPr>
              <a:t>Bacillus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 were grown on nutrient glucose agar (NGA) media supplemented with chemicals that are recommended as a part of bacterial blight management in pomegranate. These chemicals were </a:t>
            </a:r>
            <a:r>
              <a:rPr lang="en-US" dirty="0" err="1">
                <a:latin typeface="Times New Roman" pitchFamily="18" charset="0"/>
                <a:ea typeface="DengXian" pitchFamily="2" charset="-122"/>
              </a:rPr>
              <a:t>bactronol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 (2-Bromo-2-Nitro-1, 3-Propanediol), </a:t>
            </a:r>
            <a:r>
              <a:rPr lang="en-US" dirty="0" err="1">
                <a:latin typeface="Times New Roman" pitchFamily="18" charset="0"/>
                <a:ea typeface="DengXian" pitchFamily="2" charset="-122"/>
              </a:rPr>
              <a:t>Kocide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 (copper hydroxide) and </a:t>
            </a:r>
            <a:r>
              <a:rPr lang="en-US" dirty="0" err="1">
                <a:latin typeface="Times New Roman" pitchFamily="18" charset="0"/>
                <a:ea typeface="DengXian" pitchFamily="2" charset="-122"/>
              </a:rPr>
              <a:t>blitox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 (copper oxychloride) and the endophytes were (a) </a:t>
            </a:r>
            <a:r>
              <a:rPr lang="en-US" i="1" dirty="0">
                <a:latin typeface="Times New Roman" pitchFamily="18" charset="0"/>
                <a:ea typeface="DengXian" pitchFamily="2" charset="-122"/>
              </a:rPr>
              <a:t>Bacillus haynesii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 b) </a:t>
            </a:r>
            <a:r>
              <a:rPr lang="en-US" i="1" dirty="0">
                <a:latin typeface="Times New Roman" pitchFamily="18" charset="0"/>
                <a:ea typeface="DengXian" pitchFamily="2" charset="-122"/>
              </a:rPr>
              <a:t>Bacillus subtilis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 c) </a:t>
            </a:r>
            <a:r>
              <a:rPr lang="en-US" i="1" dirty="0">
                <a:latin typeface="Times New Roman" pitchFamily="18" charset="0"/>
                <a:ea typeface="DengXian" pitchFamily="2" charset="-122"/>
              </a:rPr>
              <a:t>Bacillus tequilensis</a:t>
            </a:r>
            <a:r>
              <a:rPr lang="en-US" dirty="0">
                <a:latin typeface="Times New Roman" pitchFamily="18" charset="0"/>
                <a:ea typeface="DengXian" pitchFamily="2" charset="-122"/>
              </a:rPr>
              <a:t>. NGA plates without any other chemical were used as control; clear zones indicate inhibition of growth. </a:t>
            </a:r>
            <a:endParaRPr lang="en-IN" dirty="0"/>
          </a:p>
        </p:txBody>
      </p:sp>
      <p:grpSp>
        <p:nvGrpSpPr>
          <p:cNvPr id="7171" name="Group 31"/>
          <p:cNvGrpSpPr>
            <a:grpSpLocks/>
          </p:cNvGrpSpPr>
          <p:nvPr/>
        </p:nvGrpSpPr>
        <p:grpSpPr bwMode="auto">
          <a:xfrm>
            <a:off x="543658" y="261938"/>
            <a:ext cx="5477608" cy="6078499"/>
            <a:chOff x="1564716" y="-2"/>
            <a:chExt cx="5934220" cy="6077870"/>
          </a:xfrm>
        </p:grpSpPr>
        <p:grpSp>
          <p:nvGrpSpPr>
            <p:cNvPr id="7172" name="Group 27"/>
            <p:cNvGrpSpPr>
              <a:grpSpLocks/>
            </p:cNvGrpSpPr>
            <p:nvPr/>
          </p:nvGrpSpPr>
          <p:grpSpPr bwMode="auto">
            <a:xfrm>
              <a:off x="1564716" y="2"/>
              <a:ext cx="5934220" cy="6077866"/>
              <a:chOff x="2090792" y="187456"/>
              <a:chExt cx="5934220" cy="6077866"/>
            </a:xfrm>
          </p:grpSpPr>
          <p:grpSp>
            <p:nvGrpSpPr>
              <p:cNvPr id="7176" name="Group 6"/>
              <p:cNvGrpSpPr>
                <a:grpSpLocks/>
              </p:cNvGrpSpPr>
              <p:nvPr/>
            </p:nvGrpSpPr>
            <p:grpSpPr bwMode="auto">
              <a:xfrm>
                <a:off x="2108289" y="187456"/>
                <a:ext cx="5916723" cy="1824866"/>
                <a:chOff x="2176776" y="3"/>
                <a:chExt cx="8140112" cy="2793719"/>
              </a:xfrm>
            </p:grpSpPr>
            <p:pic>
              <p:nvPicPr>
                <p:cNvPr id="7187" name="Picture 10"/>
                <p:cNvPicPr>
                  <a:picLocks noChangeAspect="1" noChangeArrowheads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2462" t="55415" r="20721" b="11470"/>
                <a:stretch>
                  <a:fillRect/>
                </a:stretch>
              </p:blipFill>
              <p:spPr bwMode="auto">
                <a:xfrm rot="-5400000">
                  <a:off x="2257619" y="665744"/>
                  <a:ext cx="2047123" cy="22088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188" name="Picture 19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4149" t="20979" r="27528" b="21394"/>
                <a:stretch>
                  <a:fillRect/>
                </a:stretch>
              </p:blipFill>
              <p:spPr bwMode="auto">
                <a:xfrm rot="5400000">
                  <a:off x="5954371" y="-1568795"/>
                  <a:ext cx="2793719" cy="593131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7177" name="Group 7"/>
              <p:cNvGrpSpPr>
                <a:grpSpLocks/>
              </p:cNvGrpSpPr>
              <p:nvPr/>
            </p:nvGrpSpPr>
            <p:grpSpPr bwMode="auto">
              <a:xfrm>
                <a:off x="2108290" y="1999577"/>
                <a:ext cx="5916721" cy="1825173"/>
                <a:chOff x="2188168" y="368706"/>
                <a:chExt cx="6426266" cy="2095743"/>
              </a:xfrm>
            </p:grpSpPr>
            <p:pic>
              <p:nvPicPr>
                <p:cNvPr id="7185" name="Picture 8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8387" t="51878" r="32077" b="27168"/>
                <a:stretch>
                  <a:fillRect/>
                </a:stretch>
              </p:blipFill>
              <p:spPr bwMode="auto">
                <a:xfrm rot="-5400000">
                  <a:off x="2144785" y="972414"/>
                  <a:ext cx="1535418" cy="14486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186" name="Picture 9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037" t="12164" r="35036" b="14162"/>
                <a:stretch>
                  <a:fillRect/>
                </a:stretch>
              </p:blipFill>
              <p:spPr bwMode="auto">
                <a:xfrm rot="5400000">
                  <a:off x="5065073" y="-1085262"/>
                  <a:ext cx="2095393" cy="500332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</p:grpSp>
          <p:grpSp>
            <p:nvGrpSpPr>
              <p:cNvPr id="7178" name="Group 16"/>
              <p:cNvGrpSpPr>
                <a:grpSpLocks/>
              </p:cNvGrpSpPr>
              <p:nvPr/>
            </p:nvGrpSpPr>
            <p:grpSpPr bwMode="auto">
              <a:xfrm>
                <a:off x="2090792" y="3824445"/>
                <a:ext cx="5934218" cy="2440877"/>
                <a:chOff x="1944033" y="391325"/>
                <a:chExt cx="7047453" cy="2454089"/>
              </a:xfrm>
            </p:grpSpPr>
            <p:pic>
              <p:nvPicPr>
                <p:cNvPr id="7179" name="Picture 17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8117" t="12392" r="28046" b="12354"/>
                <a:stretch>
                  <a:fillRect/>
                </a:stretch>
              </p:blipFill>
              <p:spPr bwMode="auto">
                <a:xfrm rot="5400000">
                  <a:off x="5333319" y="-1169533"/>
                  <a:ext cx="2097309" cy="52190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7180" name="Picture 18"/>
                <p:cNvPicPr>
                  <a:picLocks noChangeAspect="1" noChangeArrowheads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5889" t="52307" r="24525" b="24596"/>
                <a:stretch>
                  <a:fillRect/>
                </a:stretch>
              </p:blipFill>
              <p:spPr bwMode="auto">
                <a:xfrm rot="-5400000">
                  <a:off x="2131679" y="796786"/>
                  <a:ext cx="1524980" cy="185871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7181" name="TextBox 21"/>
                <p:cNvSpPr txBox="1">
                  <a:spLocks noChangeArrowheads="1"/>
                </p:cNvSpPr>
                <p:nvPr/>
              </p:nvSpPr>
              <p:spPr bwMode="auto">
                <a:xfrm>
                  <a:off x="1944033" y="2474121"/>
                  <a:ext cx="2032908" cy="371293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/>
                  <a:r>
                    <a:rPr lang="en-US" dirty="0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BACTRONOL</a:t>
                  </a:r>
                  <a:endParaRPr lang="en-IN" dirty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182" name="TextBox 22"/>
                <p:cNvSpPr txBox="1">
                  <a:spLocks noChangeArrowheads="1"/>
                </p:cNvSpPr>
                <p:nvPr/>
              </p:nvSpPr>
              <p:spPr bwMode="auto">
                <a:xfrm>
                  <a:off x="5496603" y="2474121"/>
                  <a:ext cx="1799771" cy="369332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/>
                  <a:r>
                    <a:rPr lang="en-US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CONTROL</a:t>
                  </a:r>
                  <a:endParaRPr lang="en-IN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183" name="TextBox 23"/>
                <p:cNvSpPr txBox="1">
                  <a:spLocks noChangeArrowheads="1"/>
                </p:cNvSpPr>
                <p:nvPr/>
              </p:nvSpPr>
              <p:spPr bwMode="auto">
                <a:xfrm>
                  <a:off x="3702813" y="2474121"/>
                  <a:ext cx="1799771" cy="369332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/>
                  <a:r>
                    <a:rPr lang="en-US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KOCIDE</a:t>
                  </a:r>
                  <a:endParaRPr lang="en-IN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7184" name="TextBox 24"/>
                <p:cNvSpPr txBox="1">
                  <a:spLocks noChangeArrowheads="1"/>
                </p:cNvSpPr>
                <p:nvPr/>
              </p:nvSpPr>
              <p:spPr bwMode="auto">
                <a:xfrm>
                  <a:off x="7261365" y="2474121"/>
                  <a:ext cx="1728000" cy="369332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marL="25146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marL="29718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marL="34290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marL="3886200" indent="-228600" defTabSz="457200"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algn="ctr" eaLnBrk="1" hangingPunct="1"/>
                  <a:r>
                    <a:rPr lang="en-US">
                      <a:solidFill>
                        <a:schemeClr val="bg1"/>
                      </a:solidFill>
                      <a:latin typeface="Times New Roman" pitchFamily="18" charset="0"/>
                      <a:cs typeface="Times New Roman" pitchFamily="18" charset="0"/>
                    </a:rPr>
                    <a:t>BLITOX</a:t>
                  </a:r>
                  <a:endParaRPr lang="en-IN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</p:grpSp>
        <p:sp>
          <p:nvSpPr>
            <p:cNvPr id="29" name="Rectangle 28"/>
            <p:cNvSpPr/>
            <p:nvPr/>
          </p:nvSpPr>
          <p:spPr>
            <a:xfrm>
              <a:off x="1582178" y="-2"/>
              <a:ext cx="1605002" cy="487312"/>
            </a:xfrm>
            <a:prstGeom prst="rect">
              <a:avLst/>
            </a:prstGeom>
            <a:solidFill>
              <a:srgbClr val="1C1817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/>
            </a:p>
          </p:txBody>
        </p:sp>
        <p:sp>
          <p:nvSpPr>
            <p:cNvPr id="30" name="Rectangle 29"/>
            <p:cNvSpPr/>
            <p:nvPr/>
          </p:nvSpPr>
          <p:spPr>
            <a:xfrm>
              <a:off x="1583766" y="1831783"/>
              <a:ext cx="1544675" cy="480962"/>
            </a:xfrm>
            <a:prstGeom prst="rect">
              <a:avLst/>
            </a:prstGeom>
            <a:solidFill>
              <a:srgbClr val="1C1817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/>
            </a:p>
          </p:txBody>
        </p:sp>
        <p:sp>
          <p:nvSpPr>
            <p:cNvPr id="31" name="Rectangle 30"/>
            <p:cNvSpPr/>
            <p:nvPr/>
          </p:nvSpPr>
          <p:spPr>
            <a:xfrm>
              <a:off x="1583766" y="3636584"/>
              <a:ext cx="1544675" cy="569854"/>
            </a:xfrm>
            <a:prstGeom prst="rect">
              <a:avLst/>
            </a:prstGeom>
            <a:solidFill>
              <a:srgbClr val="1C1817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en-IN"/>
            </a:p>
          </p:txBody>
        </p:sp>
      </p:grpSp>
    </p:spTree>
    <p:extLst>
      <p:ext uri="{BB962C8B-B14F-4D97-AF65-F5344CB8AC3E}">
        <p14:creationId xmlns:p14="http://schemas.microsoft.com/office/powerpoint/2010/main" val="3554871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6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nath</dc:creator>
  <cp:lastModifiedBy>Ruchi Agarrwal</cp:lastModifiedBy>
  <cp:revision>2</cp:revision>
  <dcterms:created xsi:type="dcterms:W3CDTF">2024-09-04T07:37:45Z</dcterms:created>
  <dcterms:modified xsi:type="dcterms:W3CDTF">2024-11-03T09:59:41Z</dcterms:modified>
</cp:coreProperties>
</file>